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584" r:id="rId2"/>
    <p:sldId id="585" r:id="rId3"/>
    <p:sldId id="586" r:id="rId4"/>
    <p:sldId id="587" r:id="rId5"/>
    <p:sldId id="591" r:id="rId6"/>
    <p:sldId id="588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730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138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774127-2BE7-CF44-BD52-ED0638DF3539}" type="datetimeFigureOut">
              <a:rPr lang="en-US" smtClean="0"/>
              <a:t>12/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473902-9732-5D40-AEE3-133E8EE95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06147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CC5675-C6DB-F844-B17D-454315749846}" type="datetimeFigureOut">
              <a:rPr lang="en-US" smtClean="0"/>
              <a:t>12/5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612D74-5F40-B044-9F83-4CFC0A9F50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3203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949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53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833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791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705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026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185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481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468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757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870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46DA9B-F0E3-3946-8CDF-9EFED588854D}" type="datetimeFigureOut">
              <a:rPr lang="en-US" smtClean="0"/>
              <a:t>12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90DED-DC83-A54F-9F3B-95AEEA6C0A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172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166341-80BC-F69D-EB96-A949433BE87C}"/>
              </a:ext>
            </a:extLst>
          </p:cNvPr>
          <p:cNvSpPr txBox="1"/>
          <p:nvPr/>
        </p:nvSpPr>
        <p:spPr>
          <a:xfrm>
            <a:off x="4351283" y="585472"/>
            <a:ext cx="1481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2A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0B4BDAC-7783-1330-BAD2-A6841E4EDFB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807" t="13420" r="46376" b="5358"/>
          <a:stretch/>
        </p:blipFill>
        <p:spPr>
          <a:xfrm>
            <a:off x="537217" y="1177158"/>
            <a:ext cx="3657600" cy="450368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58E045D-6BCD-BC52-1474-90A13F4EBA1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682" t="9410" r="8020" b="16948"/>
          <a:stretch/>
        </p:blipFill>
        <p:spPr>
          <a:xfrm>
            <a:off x="4194817" y="1345411"/>
            <a:ext cx="4654894" cy="4167178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7EE033F-AD3B-49F2-149C-6CD77B3A9200}"/>
              </a:ext>
            </a:extLst>
          </p:cNvPr>
          <p:cNvSpPr/>
          <p:nvPr/>
        </p:nvSpPr>
        <p:spPr>
          <a:xfrm>
            <a:off x="1399065" y="2780272"/>
            <a:ext cx="1933904" cy="41984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D237559-33A9-2536-F9F1-E790A61B5A0E}"/>
              </a:ext>
            </a:extLst>
          </p:cNvPr>
          <p:cNvSpPr txBox="1"/>
          <p:nvPr/>
        </p:nvSpPr>
        <p:spPr>
          <a:xfrm>
            <a:off x="1891862" y="5864772"/>
            <a:ext cx="1441107" cy="367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LR9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8C4B304-1C98-C7BD-AEDF-C782DA0C6EC3}"/>
              </a:ext>
            </a:extLst>
          </p:cNvPr>
          <p:cNvSpPr txBox="1"/>
          <p:nvPr/>
        </p:nvSpPr>
        <p:spPr>
          <a:xfrm>
            <a:off x="6227379" y="5849006"/>
            <a:ext cx="1441107" cy="367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802E329-DA2F-D884-011F-CE803F2A94B0}"/>
              </a:ext>
            </a:extLst>
          </p:cNvPr>
          <p:cNvSpPr/>
          <p:nvPr/>
        </p:nvSpPr>
        <p:spPr>
          <a:xfrm>
            <a:off x="5713561" y="3542272"/>
            <a:ext cx="2138856" cy="41984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1585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53CEB7-A012-0F84-73E8-00D36FA3D591}"/>
              </a:ext>
            </a:extLst>
          </p:cNvPr>
          <p:cNvSpPr txBox="1"/>
          <p:nvPr/>
        </p:nvSpPr>
        <p:spPr>
          <a:xfrm>
            <a:off x="3831020" y="617003"/>
            <a:ext cx="1481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2B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F16E841-1806-45C5-484D-DFF537863CB2}"/>
              </a:ext>
            </a:extLst>
          </p:cNvPr>
          <p:cNvSpPr/>
          <p:nvPr/>
        </p:nvSpPr>
        <p:spPr>
          <a:xfrm>
            <a:off x="4708635" y="3121572"/>
            <a:ext cx="1870841" cy="40990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14C68C4-206E-1CCB-CF9F-D2723BF29C35}"/>
              </a:ext>
            </a:extLst>
          </p:cNvPr>
          <p:cNvSpPr txBox="1"/>
          <p:nvPr/>
        </p:nvSpPr>
        <p:spPr>
          <a:xfrm>
            <a:off x="6789481" y="3167390"/>
            <a:ext cx="12028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 p-ERK1/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76A2DD-3B6E-2113-9AE3-A6CA9273AB0F}"/>
              </a:ext>
            </a:extLst>
          </p:cNvPr>
          <p:cNvSpPr txBox="1"/>
          <p:nvPr/>
        </p:nvSpPr>
        <p:spPr>
          <a:xfrm>
            <a:off x="6726700" y="5389722"/>
            <a:ext cx="1063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 GAPDH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55520FE-F6E8-3603-FAC9-4B7D878EFEA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205" t="24451" r="27221" b="5284"/>
          <a:stretch/>
        </p:blipFill>
        <p:spPr>
          <a:xfrm>
            <a:off x="364958" y="1024452"/>
            <a:ext cx="5122384" cy="501404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4F7142A-F5B7-2F56-3CA1-9D9E581299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070" t="11200" r="46814" b="12864"/>
          <a:stretch/>
        </p:blipFill>
        <p:spPr>
          <a:xfrm>
            <a:off x="4571999" y="1515282"/>
            <a:ext cx="3403128" cy="4146924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CD700D41-B6C5-FF29-BB3B-51BCDE26AE30}"/>
              </a:ext>
            </a:extLst>
          </p:cNvPr>
          <p:cNvSpPr/>
          <p:nvPr/>
        </p:nvSpPr>
        <p:spPr>
          <a:xfrm>
            <a:off x="1697420" y="2768303"/>
            <a:ext cx="2023242" cy="47939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456FE93-6380-5526-1562-E76A4425F3A5}"/>
              </a:ext>
            </a:extLst>
          </p:cNvPr>
          <p:cNvSpPr/>
          <p:nvPr/>
        </p:nvSpPr>
        <p:spPr>
          <a:xfrm>
            <a:off x="5633545" y="3291778"/>
            <a:ext cx="2023242" cy="47939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0DA7EBB-85A5-6BB4-6B22-57572B9FEF28}"/>
              </a:ext>
            </a:extLst>
          </p:cNvPr>
          <p:cNvSpPr txBox="1"/>
          <p:nvPr/>
        </p:nvSpPr>
        <p:spPr>
          <a:xfrm>
            <a:off x="1891862" y="5864772"/>
            <a:ext cx="1441107" cy="367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D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B0455B9-CF38-720F-21AF-4106D4113B61}"/>
              </a:ext>
            </a:extLst>
          </p:cNvPr>
          <p:cNvSpPr txBox="1"/>
          <p:nvPr/>
        </p:nvSpPr>
        <p:spPr>
          <a:xfrm>
            <a:off x="6215680" y="5864772"/>
            <a:ext cx="1441107" cy="367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37265180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53CEB7-A012-0F84-73E8-00D36FA3D591}"/>
              </a:ext>
            </a:extLst>
          </p:cNvPr>
          <p:cNvSpPr txBox="1"/>
          <p:nvPr/>
        </p:nvSpPr>
        <p:spPr>
          <a:xfrm>
            <a:off x="3831020" y="617003"/>
            <a:ext cx="1481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C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28B27FB-0A04-EE07-3AA4-839A7FA14EA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48" t="14188" r="14163" b="10186"/>
          <a:stretch/>
        </p:blipFill>
        <p:spPr>
          <a:xfrm>
            <a:off x="931175" y="1171806"/>
            <a:ext cx="7956330" cy="306215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E8874ED-A6B2-B148-839A-81280DE667A8}"/>
              </a:ext>
            </a:extLst>
          </p:cNvPr>
          <p:cNvSpPr txBox="1"/>
          <p:nvPr/>
        </p:nvSpPr>
        <p:spPr>
          <a:xfrm>
            <a:off x="121269" y="5681186"/>
            <a:ext cx="1014248" cy="367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6BA38BD-CAAC-B015-C219-EBD9D06BC83D}"/>
              </a:ext>
            </a:extLst>
          </p:cNvPr>
          <p:cNvSpPr/>
          <p:nvPr/>
        </p:nvSpPr>
        <p:spPr>
          <a:xfrm>
            <a:off x="1529258" y="2245780"/>
            <a:ext cx="1834052" cy="40990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ADFCFF6-9ED5-297A-91E9-AEF787CA837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494" t="15414" r="11163" b="26901"/>
          <a:stretch/>
        </p:blipFill>
        <p:spPr>
          <a:xfrm>
            <a:off x="1019503" y="3729658"/>
            <a:ext cx="7714594" cy="3062152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06873C44-E088-887F-E4F5-2D8A533D054E}"/>
              </a:ext>
            </a:extLst>
          </p:cNvPr>
          <p:cNvSpPr/>
          <p:nvPr/>
        </p:nvSpPr>
        <p:spPr>
          <a:xfrm>
            <a:off x="1426782" y="5614092"/>
            <a:ext cx="2010101" cy="40990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D10175E-EFB5-473C-C060-1FACEDD0F325}"/>
              </a:ext>
            </a:extLst>
          </p:cNvPr>
          <p:cNvSpPr txBox="1"/>
          <p:nvPr/>
        </p:nvSpPr>
        <p:spPr>
          <a:xfrm>
            <a:off x="256495" y="2245780"/>
            <a:ext cx="1014248" cy="367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16</a:t>
            </a:r>
          </a:p>
        </p:txBody>
      </p:sp>
    </p:spTree>
    <p:extLst>
      <p:ext uri="{BB962C8B-B14F-4D97-AF65-F5344CB8AC3E}">
        <p14:creationId xmlns:p14="http://schemas.microsoft.com/office/powerpoint/2010/main" val="10969041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AC0764AB-781A-99AE-5572-EB52D4E0D467}"/>
              </a:ext>
            </a:extLst>
          </p:cNvPr>
          <p:cNvSpPr txBox="1"/>
          <p:nvPr/>
        </p:nvSpPr>
        <p:spPr>
          <a:xfrm>
            <a:off x="3300248" y="694522"/>
            <a:ext cx="2937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6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9D3926F-21E1-1A47-D3D5-80B911A966F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50" t="17593" r="9666" b="30200"/>
          <a:stretch/>
        </p:blipFill>
        <p:spPr>
          <a:xfrm>
            <a:off x="1200126" y="1107207"/>
            <a:ext cx="6743747" cy="2624253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D7AC4EA2-3A6B-C410-8972-3B7B25910426}"/>
              </a:ext>
            </a:extLst>
          </p:cNvPr>
          <p:cNvSpPr/>
          <p:nvPr/>
        </p:nvSpPr>
        <p:spPr>
          <a:xfrm>
            <a:off x="2211067" y="2605267"/>
            <a:ext cx="1688271" cy="40990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68E542D-031E-69A3-8822-13207C687E7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342" t="7305" r="11988" b="42512"/>
          <a:stretch/>
        </p:blipFill>
        <p:spPr>
          <a:xfrm>
            <a:off x="1585114" y="3216165"/>
            <a:ext cx="6204998" cy="2312275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17DC0469-1653-937E-79DD-0D2E1C0E66CF}"/>
              </a:ext>
            </a:extLst>
          </p:cNvPr>
          <p:cNvSpPr/>
          <p:nvPr/>
        </p:nvSpPr>
        <p:spPr>
          <a:xfrm>
            <a:off x="2211067" y="3731460"/>
            <a:ext cx="1688271" cy="40990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8EC2844-BEB3-D07B-29E5-2ED90FC2EFD7}"/>
              </a:ext>
            </a:extLst>
          </p:cNvPr>
          <p:cNvSpPr txBox="1"/>
          <p:nvPr/>
        </p:nvSpPr>
        <p:spPr>
          <a:xfrm>
            <a:off x="599090" y="2687108"/>
            <a:ext cx="8828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-p6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3D4D163-2F09-7495-5DAA-6912663C8B17}"/>
              </a:ext>
            </a:extLst>
          </p:cNvPr>
          <p:cNvSpPr txBox="1"/>
          <p:nvPr/>
        </p:nvSpPr>
        <p:spPr>
          <a:xfrm>
            <a:off x="570866" y="3801561"/>
            <a:ext cx="1014248" cy="367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22605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22A45E3-FF7D-F131-5E99-B910F87B2C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063" r="12514" b="42856"/>
          <a:stretch/>
        </p:blipFill>
        <p:spPr>
          <a:xfrm>
            <a:off x="1292772" y="879188"/>
            <a:ext cx="6873765" cy="272218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BABDDEC-BD5C-2BB3-84F5-4FEE04D58761}"/>
              </a:ext>
            </a:extLst>
          </p:cNvPr>
          <p:cNvSpPr txBox="1"/>
          <p:nvPr/>
        </p:nvSpPr>
        <p:spPr>
          <a:xfrm>
            <a:off x="3300248" y="694522"/>
            <a:ext cx="2937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6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6E81923-1AF0-3C51-D9F3-C462E14E8AF1}"/>
              </a:ext>
            </a:extLst>
          </p:cNvPr>
          <p:cNvSpPr txBox="1"/>
          <p:nvPr/>
        </p:nvSpPr>
        <p:spPr>
          <a:xfrm>
            <a:off x="409877" y="2687107"/>
            <a:ext cx="8828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-p65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F4D95CA-C2A9-DE0F-5DB2-B8ED53C6EB6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271" t="33461" r="16523" b="34340"/>
          <a:stretch/>
        </p:blipFill>
        <p:spPr>
          <a:xfrm>
            <a:off x="1824856" y="3798119"/>
            <a:ext cx="6604441" cy="179365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20B2D55-C8ED-5C9F-6401-7581E46DCCD9}"/>
              </a:ext>
            </a:extLst>
          </p:cNvPr>
          <p:cNvSpPr txBox="1"/>
          <p:nvPr/>
        </p:nvSpPr>
        <p:spPr>
          <a:xfrm>
            <a:off x="367835" y="4694947"/>
            <a:ext cx="1014248" cy="367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E3DEF9B-1B8A-0068-65B5-F93B5BE5566B}"/>
              </a:ext>
            </a:extLst>
          </p:cNvPr>
          <p:cNvSpPr/>
          <p:nvPr/>
        </p:nvSpPr>
        <p:spPr>
          <a:xfrm>
            <a:off x="5826626" y="2677331"/>
            <a:ext cx="1772353" cy="40990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2208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BD1C2D6-1C6D-B55E-9311-5734F7158FBC}"/>
              </a:ext>
            </a:extLst>
          </p:cNvPr>
          <p:cNvSpPr txBox="1"/>
          <p:nvPr/>
        </p:nvSpPr>
        <p:spPr>
          <a:xfrm>
            <a:off x="3300248" y="694522"/>
            <a:ext cx="2937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3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AEB5D52-A469-94DB-534F-57351C5D231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912" t="16541" r="11306" b="30793"/>
          <a:stretch/>
        </p:blipFill>
        <p:spPr>
          <a:xfrm>
            <a:off x="1244160" y="1302980"/>
            <a:ext cx="7342791" cy="295720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010C24F-14AA-332E-E4B8-D2A2EC13B7FE}"/>
              </a:ext>
            </a:extLst>
          </p:cNvPr>
          <p:cNvSpPr/>
          <p:nvPr/>
        </p:nvSpPr>
        <p:spPr>
          <a:xfrm>
            <a:off x="3631318" y="3151033"/>
            <a:ext cx="1615967" cy="40990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B8AC62E-212B-2EAF-7201-A26158366DA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367" t="11068" r="13845" b="39692"/>
          <a:stretch/>
        </p:blipFill>
        <p:spPr>
          <a:xfrm>
            <a:off x="1581804" y="3920359"/>
            <a:ext cx="7120762" cy="276422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DFBDA068-759A-DF59-9C1C-F6D264A2EECC}"/>
              </a:ext>
            </a:extLst>
          </p:cNvPr>
          <p:cNvSpPr/>
          <p:nvPr/>
        </p:nvSpPr>
        <p:spPr>
          <a:xfrm>
            <a:off x="3675330" y="4824560"/>
            <a:ext cx="1716475" cy="40990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174FE24-3DAC-B2C7-D799-E5624C3BC64C}"/>
              </a:ext>
            </a:extLst>
          </p:cNvPr>
          <p:cNvSpPr txBox="1"/>
          <p:nvPr/>
        </p:nvSpPr>
        <p:spPr>
          <a:xfrm>
            <a:off x="409877" y="2687107"/>
            <a:ext cx="8828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LR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5E01F5-BBA8-3FB4-CD24-35A6E88A7C5C}"/>
              </a:ext>
            </a:extLst>
          </p:cNvPr>
          <p:cNvSpPr txBox="1"/>
          <p:nvPr/>
        </p:nvSpPr>
        <p:spPr>
          <a:xfrm>
            <a:off x="441434" y="4824560"/>
            <a:ext cx="1014248" cy="367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1766972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95</TotalTime>
  <Words>29</Words>
  <Application>Microsoft Macintosh PowerPoint</Application>
  <PresentationFormat>On-screen Show (4:3)</PresentationFormat>
  <Paragraphs>2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F Health</dc:creator>
  <cp:lastModifiedBy>Lee,Jungnam</cp:lastModifiedBy>
  <cp:revision>809</cp:revision>
  <cp:lastPrinted>2023-03-20T15:05:23Z</cp:lastPrinted>
  <dcterms:created xsi:type="dcterms:W3CDTF">2018-09-20T21:25:25Z</dcterms:created>
  <dcterms:modified xsi:type="dcterms:W3CDTF">2024-12-05T20:32:23Z</dcterms:modified>
</cp:coreProperties>
</file>